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400" cy="548639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533869" y="1900246"/>
              <a:ext cx="4797341" cy="410062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1533869" y="5246592"/>
              <a:ext cx="4797341" cy="0"/>
            </a:xfrm>
            <a:custGeom>
              <a:avLst/>
              <a:pathLst>
                <a:path w="4797341" h="0">
                  <a:moveTo>
                    <a:pt x="0" y="0"/>
                  </a:moveTo>
                  <a:lnTo>
                    <a:pt x="4797341" y="0"/>
                  </a:lnTo>
                  <a:lnTo>
                    <a:pt x="4797341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1533869" y="3769042"/>
              <a:ext cx="4797341" cy="0"/>
            </a:xfrm>
            <a:custGeom>
              <a:avLst/>
              <a:pathLst>
                <a:path w="4797341" h="0">
                  <a:moveTo>
                    <a:pt x="0" y="0"/>
                  </a:moveTo>
                  <a:lnTo>
                    <a:pt x="4797341" y="0"/>
                  </a:lnTo>
                  <a:lnTo>
                    <a:pt x="4797341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1533869" y="2291491"/>
              <a:ext cx="4797341" cy="0"/>
            </a:xfrm>
            <a:custGeom>
              <a:avLst/>
              <a:pathLst>
                <a:path w="4797341" h="0">
                  <a:moveTo>
                    <a:pt x="0" y="0"/>
                  </a:moveTo>
                  <a:lnTo>
                    <a:pt x="4797341" y="0"/>
                  </a:lnTo>
                  <a:lnTo>
                    <a:pt x="4797341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2611984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3966400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5320816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1533869" y="5985368"/>
              <a:ext cx="4797341" cy="0"/>
            </a:xfrm>
            <a:custGeom>
              <a:avLst/>
              <a:pathLst>
                <a:path w="4797341" h="0">
                  <a:moveTo>
                    <a:pt x="0" y="0"/>
                  </a:moveTo>
                  <a:lnTo>
                    <a:pt x="4797341" y="0"/>
                  </a:lnTo>
                  <a:lnTo>
                    <a:pt x="47973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1533869" y="4507817"/>
              <a:ext cx="4797341" cy="0"/>
            </a:xfrm>
            <a:custGeom>
              <a:avLst/>
              <a:pathLst>
                <a:path w="4797341" h="0">
                  <a:moveTo>
                    <a:pt x="0" y="0"/>
                  </a:moveTo>
                  <a:lnTo>
                    <a:pt x="4797341" y="0"/>
                  </a:lnTo>
                  <a:lnTo>
                    <a:pt x="47973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1533869" y="3030266"/>
              <a:ext cx="4797341" cy="0"/>
            </a:xfrm>
            <a:custGeom>
              <a:avLst/>
              <a:pathLst>
                <a:path w="4797341" h="0">
                  <a:moveTo>
                    <a:pt x="0" y="0"/>
                  </a:moveTo>
                  <a:lnTo>
                    <a:pt x="4797341" y="0"/>
                  </a:lnTo>
                  <a:lnTo>
                    <a:pt x="47973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1934776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3289192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4643608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5998024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2920114" y="38218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2920114" y="3821830"/>
              <a:ext cx="0" cy="936725"/>
            </a:xfrm>
            <a:custGeom>
              <a:avLst/>
              <a:pathLst>
                <a:path w="0" h="936725">
                  <a:moveTo>
                    <a:pt x="0" y="0"/>
                  </a:moveTo>
                  <a:lnTo>
                    <a:pt x="0" y="93672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2920114" y="47585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3194383" y="39921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3194383" y="3992119"/>
              <a:ext cx="0" cy="996046"/>
            </a:xfrm>
            <a:custGeom>
              <a:avLst/>
              <a:pathLst>
                <a:path w="0" h="996046">
                  <a:moveTo>
                    <a:pt x="0" y="0"/>
                  </a:moveTo>
                  <a:lnTo>
                    <a:pt x="0" y="99604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3194383" y="49881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2137939" y="37477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2137939" y="3747785"/>
              <a:ext cx="0" cy="947854"/>
            </a:xfrm>
            <a:custGeom>
              <a:avLst/>
              <a:pathLst>
                <a:path w="0" h="947854">
                  <a:moveTo>
                    <a:pt x="0" y="0"/>
                  </a:moveTo>
                  <a:lnTo>
                    <a:pt x="0" y="94785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2137939" y="46956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2551036" y="43901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2551036" y="4390198"/>
              <a:ext cx="0" cy="945023"/>
            </a:xfrm>
            <a:custGeom>
              <a:avLst/>
              <a:pathLst>
                <a:path w="0" h="945023">
                  <a:moveTo>
                    <a:pt x="0" y="0"/>
                  </a:moveTo>
                  <a:lnTo>
                    <a:pt x="0" y="94502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2551036" y="53352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3675201" y="27735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3675201" y="2773512"/>
              <a:ext cx="0" cy="934627"/>
            </a:xfrm>
            <a:custGeom>
              <a:avLst/>
              <a:pathLst>
                <a:path w="0" h="934627">
                  <a:moveTo>
                    <a:pt x="0" y="0"/>
                  </a:moveTo>
                  <a:lnTo>
                    <a:pt x="0" y="93462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3675201" y="37081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2418980" y="41186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2418980" y="4118649"/>
              <a:ext cx="0" cy="1045136"/>
            </a:xfrm>
            <a:custGeom>
              <a:avLst/>
              <a:pathLst>
                <a:path w="0" h="1045136">
                  <a:moveTo>
                    <a:pt x="0" y="0"/>
                  </a:moveTo>
                  <a:lnTo>
                    <a:pt x="0" y="104513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2418980" y="51637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2205660" y="39023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2205660" y="3902399"/>
              <a:ext cx="0" cy="961182"/>
            </a:xfrm>
            <a:custGeom>
              <a:avLst/>
              <a:pathLst>
                <a:path w="0" h="961182">
                  <a:moveTo>
                    <a:pt x="0" y="0"/>
                  </a:moveTo>
                  <a:lnTo>
                    <a:pt x="0" y="96118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2205660" y="48635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2821919" y="45639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2821919" y="4563940"/>
              <a:ext cx="0" cy="1177377"/>
            </a:xfrm>
            <a:custGeom>
              <a:avLst/>
              <a:pathLst>
                <a:path w="0" h="1177377">
                  <a:moveTo>
                    <a:pt x="0" y="0"/>
                  </a:moveTo>
                  <a:lnTo>
                    <a:pt x="0" y="117737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2821919" y="57413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2178571" y="36200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2178571" y="3620063"/>
              <a:ext cx="0" cy="970697"/>
            </a:xfrm>
            <a:custGeom>
              <a:avLst/>
              <a:pathLst>
                <a:path w="0" h="970697">
                  <a:moveTo>
                    <a:pt x="0" y="0"/>
                  </a:moveTo>
                  <a:lnTo>
                    <a:pt x="0" y="97069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2178571" y="45907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3739536" y="37273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3739536" y="3727338"/>
              <a:ext cx="0" cy="1333111"/>
            </a:xfrm>
            <a:custGeom>
              <a:avLst/>
              <a:pathLst>
                <a:path w="0" h="1333111">
                  <a:moveTo>
                    <a:pt x="0" y="0"/>
                  </a:moveTo>
                  <a:lnTo>
                    <a:pt x="0" y="133311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3739536" y="50604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2408822" y="33068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2408822" y="3306828"/>
              <a:ext cx="0" cy="1036773"/>
            </a:xfrm>
            <a:custGeom>
              <a:avLst/>
              <a:pathLst>
                <a:path w="0" h="1036773">
                  <a:moveTo>
                    <a:pt x="0" y="0"/>
                  </a:moveTo>
                  <a:lnTo>
                    <a:pt x="0" y="103677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2408822" y="43436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2364803" y="33910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2364803" y="3391078"/>
              <a:ext cx="0" cy="1001271"/>
            </a:xfrm>
            <a:custGeom>
              <a:avLst/>
              <a:pathLst>
                <a:path w="0" h="1001271">
                  <a:moveTo>
                    <a:pt x="0" y="0"/>
                  </a:moveTo>
                  <a:lnTo>
                    <a:pt x="0" y="100127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2364803" y="43923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2269994" y="46658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2269994" y="4665814"/>
              <a:ext cx="0" cy="942777"/>
            </a:xfrm>
            <a:custGeom>
              <a:avLst/>
              <a:pathLst>
                <a:path w="0" h="942777">
                  <a:moveTo>
                    <a:pt x="0" y="0"/>
                  </a:moveTo>
                  <a:lnTo>
                    <a:pt x="0" y="94277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2269994" y="56085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2378348" y="37671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2378348" y="3767155"/>
              <a:ext cx="0" cy="933274"/>
            </a:xfrm>
            <a:custGeom>
              <a:avLst/>
              <a:pathLst>
                <a:path w="0" h="933274">
                  <a:moveTo>
                    <a:pt x="0" y="0"/>
                  </a:moveTo>
                  <a:lnTo>
                    <a:pt x="0" y="93327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2378348" y="47004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2073604" y="37124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2073604" y="3712425"/>
              <a:ext cx="0" cy="935945"/>
            </a:xfrm>
            <a:custGeom>
              <a:avLst/>
              <a:pathLst>
                <a:path w="0" h="935945">
                  <a:moveTo>
                    <a:pt x="0" y="0"/>
                  </a:moveTo>
                  <a:lnTo>
                    <a:pt x="0" y="93594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2073604" y="46483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2798217" y="34659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2798217" y="3465955"/>
              <a:ext cx="0" cy="1121531"/>
            </a:xfrm>
            <a:custGeom>
              <a:avLst/>
              <a:pathLst>
                <a:path w="0" h="1121531">
                  <a:moveTo>
                    <a:pt x="0" y="0"/>
                  </a:moveTo>
                  <a:lnTo>
                    <a:pt x="0" y="112153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2798217" y="45874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2605212" y="48095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2605212" y="4809577"/>
              <a:ext cx="0" cy="928971"/>
            </a:xfrm>
            <a:custGeom>
              <a:avLst/>
              <a:pathLst>
                <a:path w="0" h="928971">
                  <a:moveTo>
                    <a:pt x="0" y="0"/>
                  </a:moveTo>
                  <a:lnTo>
                    <a:pt x="0" y="92897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2605212" y="57385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2588282" y="39807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2588282" y="3980750"/>
              <a:ext cx="0" cy="932689"/>
            </a:xfrm>
            <a:custGeom>
              <a:avLst/>
              <a:pathLst>
                <a:path w="0" h="932689">
                  <a:moveTo>
                    <a:pt x="0" y="0"/>
                  </a:moveTo>
                  <a:lnTo>
                    <a:pt x="0" y="93268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2588282" y="49134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5656034" y="20866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5656034" y="2086637"/>
              <a:ext cx="0" cy="1265906"/>
            </a:xfrm>
            <a:custGeom>
              <a:avLst/>
              <a:pathLst>
                <a:path w="0" h="1265906">
                  <a:moveTo>
                    <a:pt x="0" y="0"/>
                  </a:moveTo>
                  <a:lnTo>
                    <a:pt x="0" y="126590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5656034" y="33525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3702289" y="39056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3702289" y="3905686"/>
              <a:ext cx="0" cy="987127"/>
            </a:xfrm>
            <a:custGeom>
              <a:avLst/>
              <a:pathLst>
                <a:path w="0" h="987127">
                  <a:moveTo>
                    <a:pt x="0" y="0"/>
                  </a:moveTo>
                  <a:lnTo>
                    <a:pt x="0" y="98712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3702289" y="48928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2364803" y="42045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2364803" y="4204516"/>
              <a:ext cx="0" cy="1041785"/>
            </a:xfrm>
            <a:custGeom>
              <a:avLst/>
              <a:pathLst>
                <a:path w="0" h="1041785">
                  <a:moveTo>
                    <a:pt x="0" y="0"/>
                  </a:moveTo>
                  <a:lnTo>
                    <a:pt x="0" y="104178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2364803" y="52463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2364803" y="37020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3"/>
            <p:cNvSpPr/>
            <p:nvPr/>
          </p:nvSpPr>
          <p:spPr>
            <a:xfrm>
              <a:off x="2364803" y="3702077"/>
              <a:ext cx="0" cy="1136998"/>
            </a:xfrm>
            <a:custGeom>
              <a:avLst/>
              <a:pathLst>
                <a:path w="0" h="1136998">
                  <a:moveTo>
                    <a:pt x="0" y="0"/>
                  </a:moveTo>
                  <a:lnTo>
                    <a:pt x="0" y="113699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2364803" y="4839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5"/>
            <p:cNvSpPr/>
            <p:nvPr/>
          </p:nvSpPr>
          <p:spPr>
            <a:xfrm>
              <a:off x="2645845" y="40746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6"/>
            <p:cNvSpPr/>
            <p:nvPr/>
          </p:nvSpPr>
          <p:spPr>
            <a:xfrm>
              <a:off x="2645845" y="4074651"/>
              <a:ext cx="0" cy="990189"/>
            </a:xfrm>
            <a:custGeom>
              <a:avLst/>
              <a:pathLst>
                <a:path w="0" h="990189">
                  <a:moveTo>
                    <a:pt x="0" y="0"/>
                  </a:moveTo>
                  <a:lnTo>
                    <a:pt x="0" y="99018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2645845" y="50648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2662775" y="32134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2662775" y="3213497"/>
              <a:ext cx="0" cy="1279446"/>
            </a:xfrm>
            <a:custGeom>
              <a:avLst/>
              <a:pathLst>
                <a:path w="0" h="1279446">
                  <a:moveTo>
                    <a:pt x="0" y="0"/>
                  </a:moveTo>
                  <a:lnTo>
                    <a:pt x="0" y="127944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2662775" y="44929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2473157" y="42083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2473157" y="4208319"/>
              <a:ext cx="0" cy="943422"/>
            </a:xfrm>
            <a:custGeom>
              <a:avLst/>
              <a:pathLst>
                <a:path w="0" h="943422">
                  <a:moveTo>
                    <a:pt x="0" y="0"/>
                  </a:moveTo>
                  <a:lnTo>
                    <a:pt x="0" y="94342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3"/>
            <p:cNvSpPr/>
            <p:nvPr/>
          </p:nvSpPr>
          <p:spPr>
            <a:xfrm>
              <a:off x="2473157" y="51517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2442682" y="45854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l95"/>
            <p:cNvSpPr/>
            <p:nvPr/>
          </p:nvSpPr>
          <p:spPr>
            <a:xfrm>
              <a:off x="2442682" y="4585483"/>
              <a:ext cx="0" cy="1228991"/>
            </a:xfrm>
            <a:custGeom>
              <a:avLst/>
              <a:pathLst>
                <a:path w="0" h="1228991">
                  <a:moveTo>
                    <a:pt x="0" y="0"/>
                  </a:moveTo>
                  <a:lnTo>
                    <a:pt x="0" y="122899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2442682" y="58144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l97"/>
            <p:cNvSpPr/>
            <p:nvPr/>
          </p:nvSpPr>
          <p:spPr>
            <a:xfrm>
              <a:off x="2337715" y="30422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2337715" y="3042258"/>
              <a:ext cx="0" cy="1088328"/>
            </a:xfrm>
            <a:custGeom>
              <a:avLst/>
              <a:pathLst>
                <a:path w="0" h="1088328">
                  <a:moveTo>
                    <a:pt x="0" y="0"/>
                  </a:moveTo>
                  <a:lnTo>
                    <a:pt x="0" y="108832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l99"/>
            <p:cNvSpPr/>
            <p:nvPr/>
          </p:nvSpPr>
          <p:spPr>
            <a:xfrm>
              <a:off x="2337715" y="41305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2666161" y="30766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1"/>
            <p:cNvSpPr/>
            <p:nvPr/>
          </p:nvSpPr>
          <p:spPr>
            <a:xfrm>
              <a:off x="2666161" y="3076691"/>
              <a:ext cx="0" cy="1350103"/>
            </a:xfrm>
            <a:custGeom>
              <a:avLst/>
              <a:pathLst>
                <a:path w="0" h="1350103">
                  <a:moveTo>
                    <a:pt x="0" y="0"/>
                  </a:moveTo>
                  <a:lnTo>
                    <a:pt x="0" y="135010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2"/>
            <p:cNvSpPr/>
            <p:nvPr/>
          </p:nvSpPr>
          <p:spPr>
            <a:xfrm>
              <a:off x="2666161" y="44267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2964133" y="44457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4"/>
            <p:cNvSpPr/>
            <p:nvPr/>
          </p:nvSpPr>
          <p:spPr>
            <a:xfrm>
              <a:off x="2964133" y="4445757"/>
              <a:ext cx="0" cy="1240451"/>
            </a:xfrm>
            <a:custGeom>
              <a:avLst/>
              <a:pathLst>
                <a:path w="0" h="1240451">
                  <a:moveTo>
                    <a:pt x="0" y="0"/>
                  </a:moveTo>
                  <a:lnTo>
                    <a:pt x="0" y="124045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2964133" y="56862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2192115" y="38819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2192115" y="3881964"/>
              <a:ext cx="0" cy="1000006"/>
            </a:xfrm>
            <a:custGeom>
              <a:avLst/>
              <a:pathLst>
                <a:path w="0" h="1000006">
                  <a:moveTo>
                    <a:pt x="0" y="0"/>
                  </a:moveTo>
                  <a:lnTo>
                    <a:pt x="0" y="100000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2192115" y="48819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2896412" y="39705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2896412" y="3970504"/>
              <a:ext cx="0" cy="1103558"/>
            </a:xfrm>
            <a:custGeom>
              <a:avLst/>
              <a:pathLst>
                <a:path w="0" h="1103558">
                  <a:moveTo>
                    <a:pt x="0" y="0"/>
                  </a:moveTo>
                  <a:lnTo>
                    <a:pt x="0" y="110355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2896412" y="50740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2"/>
            <p:cNvSpPr/>
            <p:nvPr/>
          </p:nvSpPr>
          <p:spPr>
            <a:xfrm>
              <a:off x="2666161" y="31267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3"/>
            <p:cNvSpPr/>
            <p:nvPr/>
          </p:nvSpPr>
          <p:spPr>
            <a:xfrm>
              <a:off x="2666161" y="3126783"/>
              <a:ext cx="0" cy="1139481"/>
            </a:xfrm>
            <a:custGeom>
              <a:avLst/>
              <a:pathLst>
                <a:path w="0" h="1139481">
                  <a:moveTo>
                    <a:pt x="0" y="0"/>
                  </a:moveTo>
                  <a:lnTo>
                    <a:pt x="0" y="113948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4"/>
            <p:cNvSpPr/>
            <p:nvPr/>
          </p:nvSpPr>
          <p:spPr>
            <a:xfrm>
              <a:off x="2666161" y="42662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pl115"/>
            <p:cNvSpPr/>
            <p:nvPr/>
          </p:nvSpPr>
          <p:spPr>
            <a:xfrm>
              <a:off x="3238402" y="42901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2601826" y="4290192"/>
              <a:ext cx="636575" cy="0"/>
            </a:xfrm>
            <a:custGeom>
              <a:avLst/>
              <a:pathLst>
                <a:path w="636575" h="0">
                  <a:moveTo>
                    <a:pt x="63657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7"/>
            <p:cNvSpPr/>
            <p:nvPr/>
          </p:nvSpPr>
          <p:spPr>
            <a:xfrm>
              <a:off x="2601826" y="42901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8"/>
            <p:cNvSpPr/>
            <p:nvPr/>
          </p:nvSpPr>
          <p:spPr>
            <a:xfrm>
              <a:off x="3526215" y="44901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19"/>
            <p:cNvSpPr/>
            <p:nvPr/>
          </p:nvSpPr>
          <p:spPr>
            <a:xfrm>
              <a:off x="2862551" y="4490143"/>
              <a:ext cx="663663" cy="0"/>
            </a:xfrm>
            <a:custGeom>
              <a:avLst/>
              <a:pathLst>
                <a:path w="663663" h="0">
                  <a:moveTo>
                    <a:pt x="66366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0"/>
            <p:cNvSpPr/>
            <p:nvPr/>
          </p:nvSpPr>
          <p:spPr>
            <a:xfrm>
              <a:off x="2862551" y="44901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1"/>
            <p:cNvSpPr/>
            <p:nvPr/>
          </p:nvSpPr>
          <p:spPr>
            <a:xfrm>
              <a:off x="2469771" y="42217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l122"/>
            <p:cNvSpPr/>
            <p:nvPr/>
          </p:nvSpPr>
          <p:spPr>
            <a:xfrm>
              <a:off x="1806107" y="4221712"/>
              <a:ext cx="663663" cy="0"/>
            </a:xfrm>
            <a:custGeom>
              <a:avLst/>
              <a:pathLst>
                <a:path w="663663" h="0">
                  <a:moveTo>
                    <a:pt x="66366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3"/>
            <p:cNvSpPr/>
            <p:nvPr/>
          </p:nvSpPr>
          <p:spPr>
            <a:xfrm>
              <a:off x="1806107" y="42217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4"/>
            <p:cNvSpPr/>
            <p:nvPr/>
          </p:nvSpPr>
          <p:spPr>
            <a:xfrm>
              <a:off x="2872709" y="48627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5"/>
            <p:cNvSpPr/>
            <p:nvPr/>
          </p:nvSpPr>
          <p:spPr>
            <a:xfrm>
              <a:off x="2229362" y="4862710"/>
              <a:ext cx="643347" cy="0"/>
            </a:xfrm>
            <a:custGeom>
              <a:avLst/>
              <a:pathLst>
                <a:path w="643347" h="0">
                  <a:moveTo>
                    <a:pt x="64334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6"/>
            <p:cNvSpPr/>
            <p:nvPr/>
          </p:nvSpPr>
          <p:spPr>
            <a:xfrm>
              <a:off x="2229362" y="48627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7"/>
            <p:cNvSpPr/>
            <p:nvPr/>
          </p:nvSpPr>
          <p:spPr>
            <a:xfrm>
              <a:off x="3996875" y="32408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8"/>
            <p:cNvSpPr/>
            <p:nvPr/>
          </p:nvSpPr>
          <p:spPr>
            <a:xfrm>
              <a:off x="3353527" y="3240826"/>
              <a:ext cx="643347" cy="0"/>
            </a:xfrm>
            <a:custGeom>
              <a:avLst/>
              <a:pathLst>
                <a:path w="643347" h="0">
                  <a:moveTo>
                    <a:pt x="64334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l129"/>
            <p:cNvSpPr/>
            <p:nvPr/>
          </p:nvSpPr>
          <p:spPr>
            <a:xfrm>
              <a:off x="3353527" y="32408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pl130"/>
            <p:cNvSpPr/>
            <p:nvPr/>
          </p:nvSpPr>
          <p:spPr>
            <a:xfrm>
              <a:off x="2794831" y="46412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" name="pl131"/>
            <p:cNvSpPr/>
            <p:nvPr/>
          </p:nvSpPr>
          <p:spPr>
            <a:xfrm>
              <a:off x="2043130" y="4641218"/>
              <a:ext cx="751700" cy="0"/>
            </a:xfrm>
            <a:custGeom>
              <a:avLst/>
              <a:pathLst>
                <a:path w="751700" h="0">
                  <a:moveTo>
                    <a:pt x="75170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pl132"/>
            <p:cNvSpPr/>
            <p:nvPr/>
          </p:nvSpPr>
          <p:spPr>
            <a:xfrm>
              <a:off x="2043130" y="46412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l133"/>
            <p:cNvSpPr/>
            <p:nvPr/>
          </p:nvSpPr>
          <p:spPr>
            <a:xfrm>
              <a:off x="2547650" y="43829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4"/>
            <p:cNvSpPr/>
            <p:nvPr/>
          </p:nvSpPr>
          <p:spPr>
            <a:xfrm>
              <a:off x="1863670" y="4382990"/>
              <a:ext cx="683980" cy="0"/>
            </a:xfrm>
            <a:custGeom>
              <a:avLst/>
              <a:pathLst>
                <a:path w="683980" h="0">
                  <a:moveTo>
                    <a:pt x="6839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5"/>
            <p:cNvSpPr/>
            <p:nvPr/>
          </p:nvSpPr>
          <p:spPr>
            <a:xfrm>
              <a:off x="1863670" y="43829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l136"/>
            <p:cNvSpPr/>
            <p:nvPr/>
          </p:nvSpPr>
          <p:spPr>
            <a:xfrm>
              <a:off x="3299350" y="51526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pl137"/>
            <p:cNvSpPr/>
            <p:nvPr/>
          </p:nvSpPr>
          <p:spPr>
            <a:xfrm>
              <a:off x="2344487" y="5152629"/>
              <a:ext cx="954863" cy="0"/>
            </a:xfrm>
            <a:custGeom>
              <a:avLst/>
              <a:pathLst>
                <a:path w="954863" h="0">
                  <a:moveTo>
                    <a:pt x="95486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" name="pl138"/>
            <p:cNvSpPr/>
            <p:nvPr/>
          </p:nvSpPr>
          <p:spPr>
            <a:xfrm>
              <a:off x="2344487" y="51526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" name="pl139"/>
            <p:cNvSpPr/>
            <p:nvPr/>
          </p:nvSpPr>
          <p:spPr>
            <a:xfrm>
              <a:off x="2513789" y="41054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l140"/>
            <p:cNvSpPr/>
            <p:nvPr/>
          </p:nvSpPr>
          <p:spPr>
            <a:xfrm>
              <a:off x="1843353" y="4105412"/>
              <a:ext cx="670435" cy="0"/>
            </a:xfrm>
            <a:custGeom>
              <a:avLst/>
              <a:pathLst>
                <a:path w="670435" h="0">
                  <a:moveTo>
                    <a:pt x="67043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1"/>
            <p:cNvSpPr/>
            <p:nvPr/>
          </p:nvSpPr>
          <p:spPr>
            <a:xfrm>
              <a:off x="1843353" y="41054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2"/>
            <p:cNvSpPr/>
            <p:nvPr/>
          </p:nvSpPr>
          <p:spPr>
            <a:xfrm>
              <a:off x="4352409" y="43938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3"/>
            <p:cNvSpPr/>
            <p:nvPr/>
          </p:nvSpPr>
          <p:spPr>
            <a:xfrm>
              <a:off x="3126662" y="4393894"/>
              <a:ext cx="1225746" cy="0"/>
            </a:xfrm>
            <a:custGeom>
              <a:avLst/>
              <a:pathLst>
                <a:path w="1225746" h="0">
                  <a:moveTo>
                    <a:pt x="122574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4"/>
            <p:cNvSpPr/>
            <p:nvPr/>
          </p:nvSpPr>
          <p:spPr>
            <a:xfrm>
              <a:off x="3126662" y="43938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5"/>
            <p:cNvSpPr/>
            <p:nvPr/>
          </p:nvSpPr>
          <p:spPr>
            <a:xfrm>
              <a:off x="2771128" y="38252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6"/>
            <p:cNvSpPr/>
            <p:nvPr/>
          </p:nvSpPr>
          <p:spPr>
            <a:xfrm>
              <a:off x="2046516" y="3825215"/>
              <a:ext cx="724612" cy="0"/>
            </a:xfrm>
            <a:custGeom>
              <a:avLst/>
              <a:pathLst>
                <a:path w="724612" h="0">
                  <a:moveTo>
                    <a:pt x="72461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7"/>
            <p:cNvSpPr/>
            <p:nvPr/>
          </p:nvSpPr>
          <p:spPr>
            <a:xfrm>
              <a:off x="2046516" y="38252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8"/>
            <p:cNvSpPr/>
            <p:nvPr/>
          </p:nvSpPr>
          <p:spPr>
            <a:xfrm>
              <a:off x="2720338" y="38917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49"/>
            <p:cNvSpPr/>
            <p:nvPr/>
          </p:nvSpPr>
          <p:spPr>
            <a:xfrm>
              <a:off x="2009269" y="3891714"/>
              <a:ext cx="711068" cy="0"/>
            </a:xfrm>
            <a:custGeom>
              <a:avLst/>
              <a:pathLst>
                <a:path w="711068" h="0">
                  <a:moveTo>
                    <a:pt x="71106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0"/>
            <p:cNvSpPr/>
            <p:nvPr/>
          </p:nvSpPr>
          <p:spPr>
            <a:xfrm>
              <a:off x="2009269" y="38917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l151"/>
            <p:cNvSpPr/>
            <p:nvPr/>
          </p:nvSpPr>
          <p:spPr>
            <a:xfrm>
              <a:off x="2588282" y="51372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l152"/>
            <p:cNvSpPr/>
            <p:nvPr/>
          </p:nvSpPr>
          <p:spPr>
            <a:xfrm>
              <a:off x="1951707" y="5137203"/>
              <a:ext cx="636575" cy="0"/>
            </a:xfrm>
            <a:custGeom>
              <a:avLst/>
              <a:pathLst>
                <a:path w="636575" h="0">
                  <a:moveTo>
                    <a:pt x="63657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l153"/>
            <p:cNvSpPr/>
            <p:nvPr/>
          </p:nvSpPr>
          <p:spPr>
            <a:xfrm>
              <a:off x="1951707" y="51372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l154"/>
            <p:cNvSpPr/>
            <p:nvPr/>
          </p:nvSpPr>
          <p:spPr>
            <a:xfrm>
              <a:off x="2696635" y="42337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l155"/>
            <p:cNvSpPr/>
            <p:nvPr/>
          </p:nvSpPr>
          <p:spPr>
            <a:xfrm>
              <a:off x="2060060" y="4233792"/>
              <a:ext cx="636575" cy="0"/>
            </a:xfrm>
            <a:custGeom>
              <a:avLst/>
              <a:pathLst>
                <a:path w="636575" h="0">
                  <a:moveTo>
                    <a:pt x="63657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l156"/>
            <p:cNvSpPr/>
            <p:nvPr/>
          </p:nvSpPr>
          <p:spPr>
            <a:xfrm>
              <a:off x="2060060" y="42337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l157"/>
            <p:cNvSpPr/>
            <p:nvPr/>
          </p:nvSpPr>
          <p:spPr>
            <a:xfrm>
              <a:off x="2395278" y="41803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pl158"/>
            <p:cNvSpPr/>
            <p:nvPr/>
          </p:nvSpPr>
          <p:spPr>
            <a:xfrm>
              <a:off x="1751930" y="4180398"/>
              <a:ext cx="643347" cy="0"/>
            </a:xfrm>
            <a:custGeom>
              <a:avLst/>
              <a:pathLst>
                <a:path w="643347" h="0">
                  <a:moveTo>
                    <a:pt x="64334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" name="pl159"/>
            <p:cNvSpPr/>
            <p:nvPr/>
          </p:nvSpPr>
          <p:spPr>
            <a:xfrm>
              <a:off x="1751930" y="41803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" name="pl160"/>
            <p:cNvSpPr/>
            <p:nvPr/>
          </p:nvSpPr>
          <p:spPr>
            <a:xfrm>
              <a:off x="3190997" y="40267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" name="pl161"/>
            <p:cNvSpPr/>
            <p:nvPr/>
          </p:nvSpPr>
          <p:spPr>
            <a:xfrm>
              <a:off x="2405436" y="4026721"/>
              <a:ext cx="785561" cy="0"/>
            </a:xfrm>
            <a:custGeom>
              <a:avLst/>
              <a:pathLst>
                <a:path w="785561" h="0">
                  <a:moveTo>
                    <a:pt x="78556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" name="pl162"/>
            <p:cNvSpPr/>
            <p:nvPr/>
          </p:nvSpPr>
          <p:spPr>
            <a:xfrm>
              <a:off x="2405436" y="40267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" name="pl163"/>
            <p:cNvSpPr/>
            <p:nvPr/>
          </p:nvSpPr>
          <p:spPr>
            <a:xfrm>
              <a:off x="2923500" y="52740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" name="pl164"/>
            <p:cNvSpPr/>
            <p:nvPr/>
          </p:nvSpPr>
          <p:spPr>
            <a:xfrm>
              <a:off x="2286925" y="5274063"/>
              <a:ext cx="636575" cy="0"/>
            </a:xfrm>
            <a:custGeom>
              <a:avLst/>
              <a:pathLst>
                <a:path w="636575" h="0">
                  <a:moveTo>
                    <a:pt x="63657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" name="pl165"/>
            <p:cNvSpPr/>
            <p:nvPr/>
          </p:nvSpPr>
          <p:spPr>
            <a:xfrm>
              <a:off x="2286925" y="52740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" name="pl166"/>
            <p:cNvSpPr/>
            <p:nvPr/>
          </p:nvSpPr>
          <p:spPr>
            <a:xfrm>
              <a:off x="2906570" y="44470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" name="pl167"/>
            <p:cNvSpPr/>
            <p:nvPr/>
          </p:nvSpPr>
          <p:spPr>
            <a:xfrm>
              <a:off x="2269994" y="4447094"/>
              <a:ext cx="636575" cy="0"/>
            </a:xfrm>
            <a:custGeom>
              <a:avLst/>
              <a:pathLst>
                <a:path w="636575" h="0">
                  <a:moveTo>
                    <a:pt x="63657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" name="pl168"/>
            <p:cNvSpPr/>
            <p:nvPr/>
          </p:nvSpPr>
          <p:spPr>
            <a:xfrm>
              <a:off x="2269994" y="44470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l169"/>
            <p:cNvSpPr/>
            <p:nvPr/>
          </p:nvSpPr>
          <p:spPr>
            <a:xfrm>
              <a:off x="6113149" y="27195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l170"/>
            <p:cNvSpPr/>
            <p:nvPr/>
          </p:nvSpPr>
          <p:spPr>
            <a:xfrm>
              <a:off x="5198919" y="2719591"/>
              <a:ext cx="914230" cy="0"/>
            </a:xfrm>
            <a:custGeom>
              <a:avLst/>
              <a:pathLst>
                <a:path w="914230" h="0">
                  <a:moveTo>
                    <a:pt x="91423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l171"/>
            <p:cNvSpPr/>
            <p:nvPr/>
          </p:nvSpPr>
          <p:spPr>
            <a:xfrm>
              <a:off x="5198919" y="27195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l172"/>
            <p:cNvSpPr/>
            <p:nvPr/>
          </p:nvSpPr>
          <p:spPr>
            <a:xfrm>
              <a:off x="4037507" y="43992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l173"/>
            <p:cNvSpPr/>
            <p:nvPr/>
          </p:nvSpPr>
          <p:spPr>
            <a:xfrm>
              <a:off x="3367071" y="4399250"/>
              <a:ext cx="670435" cy="0"/>
            </a:xfrm>
            <a:custGeom>
              <a:avLst/>
              <a:pathLst>
                <a:path w="670435" h="0">
                  <a:moveTo>
                    <a:pt x="67043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l174"/>
            <p:cNvSpPr/>
            <p:nvPr/>
          </p:nvSpPr>
          <p:spPr>
            <a:xfrm>
              <a:off x="3367071" y="43992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l175"/>
            <p:cNvSpPr/>
            <p:nvPr/>
          </p:nvSpPr>
          <p:spPr>
            <a:xfrm>
              <a:off x="2733882" y="47254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l176"/>
            <p:cNvSpPr/>
            <p:nvPr/>
          </p:nvSpPr>
          <p:spPr>
            <a:xfrm>
              <a:off x="1995725" y="4725409"/>
              <a:ext cx="738156" cy="0"/>
            </a:xfrm>
            <a:custGeom>
              <a:avLst/>
              <a:pathLst>
                <a:path w="738156" h="0">
                  <a:moveTo>
                    <a:pt x="73815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l177"/>
            <p:cNvSpPr/>
            <p:nvPr/>
          </p:nvSpPr>
          <p:spPr>
            <a:xfrm>
              <a:off x="1995725" y="47254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l178"/>
            <p:cNvSpPr/>
            <p:nvPr/>
          </p:nvSpPr>
          <p:spPr>
            <a:xfrm>
              <a:off x="2750812" y="427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l179"/>
            <p:cNvSpPr/>
            <p:nvPr/>
          </p:nvSpPr>
          <p:spPr>
            <a:xfrm>
              <a:off x="1978795" y="4270576"/>
              <a:ext cx="772017" cy="0"/>
            </a:xfrm>
            <a:custGeom>
              <a:avLst/>
              <a:pathLst>
                <a:path w="772017" h="0">
                  <a:moveTo>
                    <a:pt x="77201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l180"/>
            <p:cNvSpPr/>
            <p:nvPr/>
          </p:nvSpPr>
          <p:spPr>
            <a:xfrm>
              <a:off x="1978795" y="427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l181"/>
            <p:cNvSpPr/>
            <p:nvPr/>
          </p:nvSpPr>
          <p:spPr>
            <a:xfrm>
              <a:off x="2984449" y="45697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l182"/>
            <p:cNvSpPr/>
            <p:nvPr/>
          </p:nvSpPr>
          <p:spPr>
            <a:xfrm>
              <a:off x="2307241" y="4569746"/>
              <a:ext cx="677207" cy="0"/>
            </a:xfrm>
            <a:custGeom>
              <a:avLst/>
              <a:pathLst>
                <a:path w="677207" h="0">
                  <a:moveTo>
                    <a:pt x="67720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l183"/>
            <p:cNvSpPr/>
            <p:nvPr/>
          </p:nvSpPr>
          <p:spPr>
            <a:xfrm>
              <a:off x="2307241" y="45697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l184"/>
            <p:cNvSpPr/>
            <p:nvPr/>
          </p:nvSpPr>
          <p:spPr>
            <a:xfrm>
              <a:off x="3106346" y="38532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pl185"/>
            <p:cNvSpPr/>
            <p:nvPr/>
          </p:nvSpPr>
          <p:spPr>
            <a:xfrm>
              <a:off x="2219204" y="3853221"/>
              <a:ext cx="887142" cy="0"/>
            </a:xfrm>
            <a:custGeom>
              <a:avLst/>
              <a:pathLst>
                <a:path w="887142" h="0">
                  <a:moveTo>
                    <a:pt x="88714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" name="pl186"/>
            <p:cNvSpPr/>
            <p:nvPr/>
          </p:nvSpPr>
          <p:spPr>
            <a:xfrm>
              <a:off x="2219204" y="38532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" name="pl187"/>
            <p:cNvSpPr/>
            <p:nvPr/>
          </p:nvSpPr>
          <p:spPr>
            <a:xfrm>
              <a:off x="2801603" y="46800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" name="pl188"/>
            <p:cNvSpPr/>
            <p:nvPr/>
          </p:nvSpPr>
          <p:spPr>
            <a:xfrm>
              <a:off x="2144711" y="4680030"/>
              <a:ext cx="656891" cy="0"/>
            </a:xfrm>
            <a:custGeom>
              <a:avLst/>
              <a:pathLst>
                <a:path w="656891" h="0">
                  <a:moveTo>
                    <a:pt x="65689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" name="pl189"/>
            <p:cNvSpPr/>
            <p:nvPr/>
          </p:nvSpPr>
          <p:spPr>
            <a:xfrm>
              <a:off x="2144711" y="46800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pl190"/>
            <p:cNvSpPr/>
            <p:nvPr/>
          </p:nvSpPr>
          <p:spPr>
            <a:xfrm>
              <a:off x="2828691" y="51999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" name="pl191"/>
            <p:cNvSpPr/>
            <p:nvPr/>
          </p:nvSpPr>
          <p:spPr>
            <a:xfrm>
              <a:off x="2056674" y="5199979"/>
              <a:ext cx="772017" cy="0"/>
            </a:xfrm>
            <a:custGeom>
              <a:avLst/>
              <a:pathLst>
                <a:path w="772017" h="0">
                  <a:moveTo>
                    <a:pt x="77201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" name="pl192"/>
            <p:cNvSpPr/>
            <p:nvPr/>
          </p:nvSpPr>
          <p:spPr>
            <a:xfrm>
              <a:off x="2056674" y="51999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" name="pl193"/>
            <p:cNvSpPr/>
            <p:nvPr/>
          </p:nvSpPr>
          <p:spPr>
            <a:xfrm>
              <a:off x="2713566" y="35864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" name="pl194"/>
            <p:cNvSpPr/>
            <p:nvPr/>
          </p:nvSpPr>
          <p:spPr>
            <a:xfrm>
              <a:off x="1961865" y="3586422"/>
              <a:ext cx="751700" cy="0"/>
            </a:xfrm>
            <a:custGeom>
              <a:avLst/>
              <a:pathLst>
                <a:path w="751700" h="0">
                  <a:moveTo>
                    <a:pt x="75170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" name="pl195"/>
            <p:cNvSpPr/>
            <p:nvPr/>
          </p:nvSpPr>
          <p:spPr>
            <a:xfrm>
              <a:off x="1961865" y="35864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" name="pl196"/>
            <p:cNvSpPr/>
            <p:nvPr/>
          </p:nvSpPr>
          <p:spPr>
            <a:xfrm>
              <a:off x="3082644" y="37517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" name="pl197"/>
            <p:cNvSpPr/>
            <p:nvPr/>
          </p:nvSpPr>
          <p:spPr>
            <a:xfrm>
              <a:off x="2249678" y="3751743"/>
              <a:ext cx="832965" cy="0"/>
            </a:xfrm>
            <a:custGeom>
              <a:avLst/>
              <a:pathLst>
                <a:path w="832965" h="0">
                  <a:moveTo>
                    <a:pt x="83296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" name="pl198"/>
            <p:cNvSpPr/>
            <p:nvPr/>
          </p:nvSpPr>
          <p:spPr>
            <a:xfrm>
              <a:off x="2249678" y="37517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" name="pl199"/>
            <p:cNvSpPr/>
            <p:nvPr/>
          </p:nvSpPr>
          <p:spPr>
            <a:xfrm>
              <a:off x="3356913" y="50659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" name="pl200"/>
            <p:cNvSpPr/>
            <p:nvPr/>
          </p:nvSpPr>
          <p:spPr>
            <a:xfrm>
              <a:off x="2571352" y="5065983"/>
              <a:ext cx="785561" cy="0"/>
            </a:xfrm>
            <a:custGeom>
              <a:avLst/>
              <a:pathLst>
                <a:path w="785561" h="0">
                  <a:moveTo>
                    <a:pt x="78556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" name="pl201"/>
            <p:cNvSpPr/>
            <p:nvPr/>
          </p:nvSpPr>
          <p:spPr>
            <a:xfrm>
              <a:off x="2571352" y="50659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" name="pl202"/>
            <p:cNvSpPr/>
            <p:nvPr/>
          </p:nvSpPr>
          <p:spPr>
            <a:xfrm>
              <a:off x="2523947" y="43819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" name="pl203"/>
            <p:cNvSpPr/>
            <p:nvPr/>
          </p:nvSpPr>
          <p:spPr>
            <a:xfrm>
              <a:off x="1860284" y="4381967"/>
              <a:ext cx="663663" cy="0"/>
            </a:xfrm>
            <a:custGeom>
              <a:avLst/>
              <a:pathLst>
                <a:path w="663663" h="0">
                  <a:moveTo>
                    <a:pt x="66366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" name="pl204"/>
            <p:cNvSpPr/>
            <p:nvPr/>
          </p:nvSpPr>
          <p:spPr>
            <a:xfrm>
              <a:off x="1860284" y="43819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" name="pl205"/>
            <p:cNvSpPr/>
            <p:nvPr/>
          </p:nvSpPr>
          <p:spPr>
            <a:xfrm>
              <a:off x="3265490" y="45222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" name="pl206"/>
            <p:cNvSpPr/>
            <p:nvPr/>
          </p:nvSpPr>
          <p:spPr>
            <a:xfrm>
              <a:off x="2527333" y="4522284"/>
              <a:ext cx="738156" cy="0"/>
            </a:xfrm>
            <a:custGeom>
              <a:avLst/>
              <a:pathLst>
                <a:path w="738156" h="0">
                  <a:moveTo>
                    <a:pt x="73815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" name="pl207"/>
            <p:cNvSpPr/>
            <p:nvPr/>
          </p:nvSpPr>
          <p:spPr>
            <a:xfrm>
              <a:off x="2527333" y="45222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" name="pl208"/>
            <p:cNvSpPr/>
            <p:nvPr/>
          </p:nvSpPr>
          <p:spPr>
            <a:xfrm>
              <a:off x="3069100" y="36965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" name="pl209"/>
            <p:cNvSpPr/>
            <p:nvPr/>
          </p:nvSpPr>
          <p:spPr>
            <a:xfrm>
              <a:off x="2263222" y="3696523"/>
              <a:ext cx="805877" cy="0"/>
            </a:xfrm>
            <a:custGeom>
              <a:avLst/>
              <a:pathLst>
                <a:path w="805877" h="0">
                  <a:moveTo>
                    <a:pt x="80587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" name="pl210"/>
            <p:cNvSpPr/>
            <p:nvPr/>
          </p:nvSpPr>
          <p:spPr>
            <a:xfrm>
              <a:off x="2263222" y="36965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" name="pt211"/>
            <p:cNvSpPr/>
            <p:nvPr/>
          </p:nvSpPr>
          <p:spPr>
            <a:xfrm>
              <a:off x="2895288" y="42653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" name="pt212"/>
            <p:cNvSpPr/>
            <p:nvPr/>
          </p:nvSpPr>
          <p:spPr>
            <a:xfrm>
              <a:off x="3169557" y="44653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" name="pt213"/>
            <p:cNvSpPr/>
            <p:nvPr/>
          </p:nvSpPr>
          <p:spPr>
            <a:xfrm>
              <a:off x="2113113" y="41968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" name="pt214"/>
            <p:cNvSpPr/>
            <p:nvPr/>
          </p:nvSpPr>
          <p:spPr>
            <a:xfrm>
              <a:off x="2526210" y="483788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" name="pt215"/>
            <p:cNvSpPr/>
            <p:nvPr/>
          </p:nvSpPr>
          <p:spPr>
            <a:xfrm>
              <a:off x="3650375" y="321600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" name="pt216"/>
            <p:cNvSpPr/>
            <p:nvPr/>
          </p:nvSpPr>
          <p:spPr>
            <a:xfrm>
              <a:off x="2394154" y="46163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" name="pt217"/>
            <p:cNvSpPr/>
            <p:nvPr/>
          </p:nvSpPr>
          <p:spPr>
            <a:xfrm>
              <a:off x="2180834" y="43581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" name="pt218"/>
            <p:cNvSpPr/>
            <p:nvPr/>
          </p:nvSpPr>
          <p:spPr>
            <a:xfrm>
              <a:off x="2797093" y="512780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" name="pt219"/>
            <p:cNvSpPr/>
            <p:nvPr/>
          </p:nvSpPr>
          <p:spPr>
            <a:xfrm>
              <a:off x="2153745" y="40805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" name="pt220"/>
            <p:cNvSpPr/>
            <p:nvPr/>
          </p:nvSpPr>
          <p:spPr>
            <a:xfrm>
              <a:off x="3714710" y="43690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" name="pt221"/>
            <p:cNvSpPr/>
            <p:nvPr/>
          </p:nvSpPr>
          <p:spPr>
            <a:xfrm>
              <a:off x="2383996" y="38003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" name="pt222"/>
            <p:cNvSpPr/>
            <p:nvPr/>
          </p:nvSpPr>
          <p:spPr>
            <a:xfrm>
              <a:off x="2339978" y="38668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" name="pt223"/>
            <p:cNvSpPr/>
            <p:nvPr/>
          </p:nvSpPr>
          <p:spPr>
            <a:xfrm>
              <a:off x="2245168" y="51123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" name="pt224"/>
            <p:cNvSpPr/>
            <p:nvPr/>
          </p:nvSpPr>
          <p:spPr>
            <a:xfrm>
              <a:off x="2353522" y="42089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" name="pt225"/>
            <p:cNvSpPr/>
            <p:nvPr/>
          </p:nvSpPr>
          <p:spPr>
            <a:xfrm>
              <a:off x="2048778" y="41555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" name="pt226"/>
            <p:cNvSpPr/>
            <p:nvPr/>
          </p:nvSpPr>
          <p:spPr>
            <a:xfrm>
              <a:off x="2773391" y="40018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" name="pt227"/>
            <p:cNvSpPr/>
            <p:nvPr/>
          </p:nvSpPr>
          <p:spPr>
            <a:xfrm>
              <a:off x="2580386" y="524923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" name="pt228"/>
            <p:cNvSpPr/>
            <p:nvPr/>
          </p:nvSpPr>
          <p:spPr>
            <a:xfrm>
              <a:off x="2563456" y="44222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" name="pt229"/>
            <p:cNvSpPr/>
            <p:nvPr/>
          </p:nvSpPr>
          <p:spPr>
            <a:xfrm>
              <a:off x="5631208" y="26947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" name="pt230"/>
            <p:cNvSpPr/>
            <p:nvPr/>
          </p:nvSpPr>
          <p:spPr>
            <a:xfrm>
              <a:off x="3677463" y="43744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" name="pt231"/>
            <p:cNvSpPr/>
            <p:nvPr/>
          </p:nvSpPr>
          <p:spPr>
            <a:xfrm>
              <a:off x="2339978" y="47005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" name="pt232"/>
            <p:cNvSpPr/>
            <p:nvPr/>
          </p:nvSpPr>
          <p:spPr>
            <a:xfrm>
              <a:off x="2339978" y="42457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" name="pt233"/>
            <p:cNvSpPr/>
            <p:nvPr/>
          </p:nvSpPr>
          <p:spPr>
            <a:xfrm>
              <a:off x="2621019" y="45449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" name="pt234"/>
            <p:cNvSpPr/>
            <p:nvPr/>
          </p:nvSpPr>
          <p:spPr>
            <a:xfrm>
              <a:off x="2637949" y="38283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" name="pt235"/>
            <p:cNvSpPr/>
            <p:nvPr/>
          </p:nvSpPr>
          <p:spPr>
            <a:xfrm>
              <a:off x="2448331" y="46552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" name="pt236"/>
            <p:cNvSpPr/>
            <p:nvPr/>
          </p:nvSpPr>
          <p:spPr>
            <a:xfrm>
              <a:off x="2417856" y="51751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" name="pt237"/>
            <p:cNvSpPr/>
            <p:nvPr/>
          </p:nvSpPr>
          <p:spPr>
            <a:xfrm>
              <a:off x="2312889" y="35615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" name="pt238"/>
            <p:cNvSpPr/>
            <p:nvPr/>
          </p:nvSpPr>
          <p:spPr>
            <a:xfrm>
              <a:off x="2641335" y="37269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" name="pt239"/>
            <p:cNvSpPr/>
            <p:nvPr/>
          </p:nvSpPr>
          <p:spPr>
            <a:xfrm>
              <a:off x="2939307" y="50411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" name="pt240"/>
            <p:cNvSpPr/>
            <p:nvPr/>
          </p:nvSpPr>
          <p:spPr>
            <a:xfrm>
              <a:off x="2167289" y="43571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" name="pt241"/>
            <p:cNvSpPr/>
            <p:nvPr/>
          </p:nvSpPr>
          <p:spPr>
            <a:xfrm>
              <a:off x="2871586" y="44974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" name="pt242"/>
            <p:cNvSpPr/>
            <p:nvPr/>
          </p:nvSpPr>
          <p:spPr>
            <a:xfrm>
              <a:off x="2641335" y="367169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" name="pl243"/>
            <p:cNvSpPr/>
            <p:nvPr/>
          </p:nvSpPr>
          <p:spPr>
            <a:xfrm>
              <a:off x="1533869" y="3926314"/>
              <a:ext cx="4797341" cy="485088"/>
            </a:xfrm>
            <a:custGeom>
              <a:avLst/>
              <a:pathLst>
                <a:path w="4797341" h="485088">
                  <a:moveTo>
                    <a:pt x="0" y="485088"/>
                  </a:moveTo>
                  <a:lnTo>
                    <a:pt x="4797341" y="0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" name="pl244"/>
            <p:cNvSpPr/>
            <p:nvPr/>
          </p:nvSpPr>
          <p:spPr>
            <a:xfrm>
              <a:off x="1533869" y="3039014"/>
              <a:ext cx="4797341" cy="1710648"/>
            </a:xfrm>
            <a:custGeom>
              <a:avLst/>
              <a:pathLst>
                <a:path w="4797341" h="1710648">
                  <a:moveTo>
                    <a:pt x="0" y="1710648"/>
                  </a:moveTo>
                  <a:lnTo>
                    <a:pt x="4797341" y="0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" name="pl245"/>
            <p:cNvSpPr/>
            <p:nvPr/>
          </p:nvSpPr>
          <p:spPr>
            <a:xfrm>
              <a:off x="1533869" y="4064740"/>
              <a:ext cx="4797341" cy="369613"/>
            </a:xfrm>
            <a:custGeom>
              <a:avLst/>
              <a:pathLst>
                <a:path w="4797341" h="369613">
                  <a:moveTo>
                    <a:pt x="0" y="369613"/>
                  </a:moveTo>
                  <a:lnTo>
                    <a:pt x="4797341" y="0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" name="pl246"/>
            <p:cNvSpPr/>
            <p:nvPr/>
          </p:nvSpPr>
          <p:spPr>
            <a:xfrm>
              <a:off x="1533869" y="4273947"/>
              <a:ext cx="4797341" cy="195093"/>
            </a:xfrm>
            <a:custGeom>
              <a:avLst/>
              <a:pathLst>
                <a:path w="4797341" h="195093">
                  <a:moveTo>
                    <a:pt x="0" y="195093"/>
                  </a:moveTo>
                  <a:lnTo>
                    <a:pt x="4797341" y="0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" name="tx247"/>
            <p:cNvSpPr/>
            <p:nvPr/>
          </p:nvSpPr>
          <p:spPr>
            <a:xfrm>
              <a:off x="1148183" y="5943676"/>
              <a:ext cx="323056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5e-04</a:t>
              </a:r>
            </a:p>
          </p:txBody>
        </p:sp>
        <p:sp>
          <p:nvSpPr>
            <p:cNvPr id="249" name="tx248"/>
            <p:cNvSpPr/>
            <p:nvPr/>
          </p:nvSpPr>
          <p:spPr>
            <a:xfrm>
              <a:off x="1157351" y="4466125"/>
              <a:ext cx="313888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e+00</a:t>
              </a:r>
            </a:p>
          </p:txBody>
        </p:sp>
        <p:sp>
          <p:nvSpPr>
            <p:cNvPr id="250" name="tx249"/>
            <p:cNvSpPr/>
            <p:nvPr/>
          </p:nvSpPr>
          <p:spPr>
            <a:xfrm>
              <a:off x="1185400" y="2988575"/>
              <a:ext cx="285839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5e-04</a:t>
              </a:r>
            </a:p>
          </p:txBody>
        </p:sp>
        <p:sp>
          <p:nvSpPr>
            <p:cNvPr id="251" name="pl250"/>
            <p:cNvSpPr/>
            <p:nvPr/>
          </p:nvSpPr>
          <p:spPr>
            <a:xfrm>
              <a:off x="1499075" y="598536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" name="pl251"/>
            <p:cNvSpPr/>
            <p:nvPr/>
          </p:nvSpPr>
          <p:spPr>
            <a:xfrm>
              <a:off x="1499075" y="450781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" name="pl252"/>
            <p:cNvSpPr/>
            <p:nvPr/>
          </p:nvSpPr>
          <p:spPr>
            <a:xfrm>
              <a:off x="1499075" y="303026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" name="pl253"/>
            <p:cNvSpPr/>
            <p:nvPr/>
          </p:nvSpPr>
          <p:spPr>
            <a:xfrm>
              <a:off x="1934776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" name="pl254"/>
            <p:cNvSpPr/>
            <p:nvPr/>
          </p:nvSpPr>
          <p:spPr>
            <a:xfrm>
              <a:off x="3289192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" name="pl255"/>
            <p:cNvSpPr/>
            <p:nvPr/>
          </p:nvSpPr>
          <p:spPr>
            <a:xfrm>
              <a:off x="4643608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" name="pl256"/>
            <p:cNvSpPr/>
            <p:nvPr/>
          </p:nvSpPr>
          <p:spPr>
            <a:xfrm>
              <a:off x="5998024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" name="tx257"/>
            <p:cNvSpPr/>
            <p:nvPr/>
          </p:nvSpPr>
          <p:spPr>
            <a:xfrm>
              <a:off x="1826018" y="6061805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4</a:t>
              </a:r>
            </a:p>
          </p:txBody>
        </p:sp>
        <p:sp>
          <p:nvSpPr>
            <p:cNvPr id="259" name="tx258"/>
            <p:cNvSpPr/>
            <p:nvPr/>
          </p:nvSpPr>
          <p:spPr>
            <a:xfrm>
              <a:off x="3180434" y="6061805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8</a:t>
              </a:r>
            </a:p>
          </p:txBody>
        </p:sp>
        <p:sp>
          <p:nvSpPr>
            <p:cNvPr id="260" name="tx259"/>
            <p:cNvSpPr/>
            <p:nvPr/>
          </p:nvSpPr>
          <p:spPr>
            <a:xfrm>
              <a:off x="4534850" y="6061805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12</a:t>
              </a:r>
            </a:p>
          </p:txBody>
        </p:sp>
        <p:sp>
          <p:nvSpPr>
            <p:cNvPr id="261" name="tx260"/>
            <p:cNvSpPr/>
            <p:nvPr/>
          </p:nvSpPr>
          <p:spPr>
            <a:xfrm>
              <a:off x="5889266" y="6061805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16</a:t>
              </a:r>
            </a:p>
          </p:txBody>
        </p:sp>
        <p:sp>
          <p:nvSpPr>
            <p:cNvPr id="262" name="tx261"/>
            <p:cNvSpPr/>
            <p:nvPr/>
          </p:nvSpPr>
          <p:spPr>
            <a:xfrm>
              <a:off x="3194817" y="6172343"/>
              <a:ext cx="1475444" cy="12946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NP effect on exposure</a:t>
              </a:r>
            </a:p>
          </p:txBody>
        </p:sp>
        <p:sp>
          <p:nvSpPr>
            <p:cNvPr id="263" name="tx262"/>
            <p:cNvSpPr/>
            <p:nvPr/>
          </p:nvSpPr>
          <p:spPr>
            <a:xfrm rot="-5400000">
              <a:off x="-1339751" y="3884969"/>
              <a:ext cx="4716307" cy="13117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NP effect on Operation code: pilonidal sinus surgery (anal) || id:ukb-b-5617</a:t>
              </a:r>
            </a:p>
          </p:txBody>
        </p:sp>
        <p:sp>
          <p:nvSpPr>
            <p:cNvPr id="264" name="rc263"/>
            <p:cNvSpPr/>
            <p:nvPr/>
          </p:nvSpPr>
          <p:spPr>
            <a:xfrm>
              <a:off x="2455045" y="983989"/>
              <a:ext cx="2954990" cy="777078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265" name="tx264"/>
            <p:cNvSpPr/>
            <p:nvPr/>
          </p:nvSpPr>
          <p:spPr>
            <a:xfrm>
              <a:off x="2524634" y="1066640"/>
              <a:ext cx="527763" cy="10163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Test</a:t>
              </a:r>
            </a:p>
          </p:txBody>
        </p:sp>
        <p:sp>
          <p:nvSpPr>
            <p:cNvPr id="266" name="rc265"/>
            <p:cNvSpPr/>
            <p:nvPr/>
          </p:nvSpPr>
          <p:spPr>
            <a:xfrm>
              <a:off x="2524634" y="1252566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267" name="pl266"/>
            <p:cNvSpPr/>
            <p:nvPr/>
          </p:nvSpPr>
          <p:spPr>
            <a:xfrm>
              <a:off x="2524634" y="1252566"/>
              <a:ext cx="219456" cy="219455"/>
            </a:xfrm>
            <a:custGeom>
              <a:avLst/>
              <a:pathLst>
                <a:path w="219456" h="219455">
                  <a:moveTo>
                    <a:pt x="0" y="219455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" name="rc267"/>
            <p:cNvSpPr/>
            <p:nvPr/>
          </p:nvSpPr>
          <p:spPr>
            <a:xfrm>
              <a:off x="2524634" y="1472022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269" name="pl268"/>
            <p:cNvSpPr/>
            <p:nvPr/>
          </p:nvSpPr>
          <p:spPr>
            <a:xfrm>
              <a:off x="2524634" y="1472022"/>
              <a:ext cx="219456" cy="219456"/>
            </a:xfrm>
            <a:custGeom>
              <a:avLst/>
              <a:pathLst>
                <a:path w="219456" h="219456">
                  <a:moveTo>
                    <a:pt x="0" y="219456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" name="rc269"/>
            <p:cNvSpPr/>
            <p:nvPr/>
          </p:nvSpPr>
          <p:spPr>
            <a:xfrm>
              <a:off x="4181659" y="1252566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271" name="pl270"/>
            <p:cNvSpPr/>
            <p:nvPr/>
          </p:nvSpPr>
          <p:spPr>
            <a:xfrm>
              <a:off x="4181659" y="1252566"/>
              <a:ext cx="219455" cy="219455"/>
            </a:xfrm>
            <a:custGeom>
              <a:avLst/>
              <a:pathLst>
                <a:path w="219455" h="219455">
                  <a:moveTo>
                    <a:pt x="0" y="219455"/>
                  </a:moveTo>
                  <a:lnTo>
                    <a:pt x="219455" y="0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" name="rc271"/>
            <p:cNvSpPr/>
            <p:nvPr/>
          </p:nvSpPr>
          <p:spPr>
            <a:xfrm>
              <a:off x="4181659" y="1472022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273" name="pl272"/>
            <p:cNvSpPr/>
            <p:nvPr/>
          </p:nvSpPr>
          <p:spPr>
            <a:xfrm>
              <a:off x="4181659" y="1472022"/>
              <a:ext cx="219455" cy="219456"/>
            </a:xfrm>
            <a:custGeom>
              <a:avLst/>
              <a:pathLst>
                <a:path w="219455" h="219456">
                  <a:moveTo>
                    <a:pt x="0" y="219456"/>
                  </a:moveTo>
                  <a:lnTo>
                    <a:pt x="219455" y="0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" name="tx273"/>
            <p:cNvSpPr/>
            <p:nvPr/>
          </p:nvSpPr>
          <p:spPr>
            <a:xfrm>
              <a:off x="2813679" y="1298775"/>
              <a:ext cx="1298391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Inverse variance weighted</a:t>
              </a:r>
            </a:p>
          </p:txBody>
        </p:sp>
        <p:sp>
          <p:nvSpPr>
            <p:cNvPr id="275" name="tx274"/>
            <p:cNvSpPr/>
            <p:nvPr/>
          </p:nvSpPr>
          <p:spPr>
            <a:xfrm>
              <a:off x="2813679" y="1518231"/>
              <a:ext cx="503083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Egger</a:t>
              </a:r>
            </a:p>
          </p:txBody>
        </p:sp>
        <p:sp>
          <p:nvSpPr>
            <p:cNvPr id="276" name="tx275"/>
            <p:cNvSpPr/>
            <p:nvPr/>
          </p:nvSpPr>
          <p:spPr>
            <a:xfrm>
              <a:off x="4470704" y="1298775"/>
              <a:ext cx="869741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eighted median</a:t>
              </a:r>
            </a:p>
          </p:txBody>
        </p:sp>
        <p:sp>
          <p:nvSpPr>
            <p:cNvPr id="277" name="tx276"/>
            <p:cNvSpPr/>
            <p:nvPr/>
          </p:nvSpPr>
          <p:spPr>
            <a:xfrm>
              <a:off x="4470704" y="1518231"/>
              <a:ext cx="782756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eighted mode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11-09T20:53:26Z</dcterms:modified>
  <cp:category/>
</cp:coreProperties>
</file>